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12192000" cy="6858000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 varScale="1">
        <p:scale>
          <a:sx n="123" d="100"/>
          <a:sy n="123" d="100"/>
        </p:scale>
        <p:origin x="114" y="27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3ADA6F4-10C3-4383-8D8D-71C775093D1A}" type="datetimeFigureOut">
              <a:rPr lang="ko-KR" altLang="en-US" smtClean="0"/>
              <a:t>2022-10-1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16D916E-F6AD-4E57-A4CA-7AE15CC622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64044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/>
              <a:t>Table</a:t>
            </a:r>
            <a:r>
              <a:rPr lang="en-US" altLang="ko-KR" baseline="0" dirty="0"/>
              <a:t> 2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0F8C89C-31B9-4BB3-A5ED-9A777E4B9257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009935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1A51E-755F-451C-89D7-CCC9E401766E}" type="datetimeFigureOut">
              <a:rPr lang="ko-KR" altLang="en-US" smtClean="0"/>
              <a:t>2022-10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64DA8-C782-468C-8F0F-57D7FF5492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979741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1A51E-755F-451C-89D7-CCC9E401766E}" type="datetimeFigureOut">
              <a:rPr lang="ko-KR" altLang="en-US" smtClean="0"/>
              <a:t>2022-10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64DA8-C782-468C-8F0F-57D7FF5492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632649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1A51E-755F-451C-89D7-CCC9E401766E}" type="datetimeFigureOut">
              <a:rPr lang="ko-KR" altLang="en-US" smtClean="0"/>
              <a:t>2022-10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64DA8-C782-468C-8F0F-57D7FF5492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608897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1A51E-755F-451C-89D7-CCC9E401766E}" type="datetimeFigureOut">
              <a:rPr lang="ko-KR" altLang="en-US" smtClean="0"/>
              <a:t>2022-10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64DA8-C782-468C-8F0F-57D7FF5492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94902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1A51E-755F-451C-89D7-CCC9E401766E}" type="datetimeFigureOut">
              <a:rPr lang="ko-KR" altLang="en-US" smtClean="0"/>
              <a:t>2022-10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64DA8-C782-468C-8F0F-57D7FF5492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918137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1A51E-755F-451C-89D7-CCC9E401766E}" type="datetimeFigureOut">
              <a:rPr lang="ko-KR" altLang="en-US" smtClean="0"/>
              <a:t>2022-10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64DA8-C782-468C-8F0F-57D7FF5492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052044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1A51E-755F-451C-89D7-CCC9E401766E}" type="datetimeFigureOut">
              <a:rPr lang="ko-KR" altLang="en-US" smtClean="0"/>
              <a:t>2022-10-12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64DA8-C782-468C-8F0F-57D7FF5492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153217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1A51E-755F-451C-89D7-CCC9E401766E}" type="datetimeFigureOut">
              <a:rPr lang="ko-KR" altLang="en-US" smtClean="0"/>
              <a:t>2022-10-1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64DA8-C782-468C-8F0F-57D7FF5492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147372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1A51E-755F-451C-89D7-CCC9E401766E}" type="datetimeFigureOut">
              <a:rPr lang="ko-KR" altLang="en-US" smtClean="0"/>
              <a:t>2022-10-12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64DA8-C782-468C-8F0F-57D7FF5492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142638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1A51E-755F-451C-89D7-CCC9E401766E}" type="datetimeFigureOut">
              <a:rPr lang="ko-KR" altLang="en-US" smtClean="0"/>
              <a:t>2022-10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64DA8-C782-468C-8F0F-57D7FF5492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369194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1A51E-755F-451C-89D7-CCC9E401766E}" type="datetimeFigureOut">
              <a:rPr lang="ko-KR" altLang="en-US" smtClean="0"/>
              <a:t>2022-10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64DA8-C782-468C-8F0F-57D7FF5492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869440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E1A51E-755F-451C-89D7-CCC9E401766E}" type="datetimeFigureOut">
              <a:rPr lang="ko-KR" altLang="en-US" smtClean="0"/>
              <a:t>2022-10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964DA8-C782-468C-8F0F-57D7FF5492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424427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표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64217896"/>
              </p:ext>
            </p:extLst>
          </p:nvPr>
        </p:nvGraphicFramePr>
        <p:xfrm>
          <a:off x="3139976" y="687653"/>
          <a:ext cx="6763441" cy="5094110"/>
        </p:xfrm>
        <a:graphic>
          <a:graphicData uri="http://schemas.openxmlformats.org/drawingml/2006/table">
            <a:tbl>
              <a:tblPr/>
              <a:tblGrid>
                <a:gridCol w="168795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65703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6055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8069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945228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731976">
                  <a:extLst>
                    <a:ext uri="{9D8B030D-6E8A-4147-A177-3AD203B41FA5}">
                      <a16:colId xmlns:a16="http://schemas.microsoft.com/office/drawing/2014/main" val="1982451400"/>
                    </a:ext>
                  </a:extLst>
                </a:gridCol>
              </a:tblGrid>
              <a:tr h="279477">
                <a:tc rowSpan="2">
                  <a:txBody>
                    <a:bodyPr/>
                    <a:lstStyle/>
                    <a:p>
                      <a:pPr algn="just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Compoun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Concentration</a:t>
                      </a:r>
                    </a:p>
                    <a:p>
                      <a:pPr algn="just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      (ng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Intra-day(n=3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Inter-day(n=5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just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79477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ean ± S.D.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ean±S.D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just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430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eleutheroside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B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 0.1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0.18 ± 0.0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 0.18 ± 0.00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79477"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 100.0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13.95 ± 0.9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4.11 ± 1.9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79477"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 200.0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.98 ± 1.6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.62 ± 5.4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79477"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 500.0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00.17 ± 0.3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97.44 ± 2.6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7947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eleutheroside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 0.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 0.24 ± 0.00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 0.24 ± 0.00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79477"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 100.0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7.75 ± 1.3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6.67 ± 3.3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79477"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 200.0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.99 ± 5.8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2.07 ± 6.2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79477"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 500.0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90.68 ± 13.6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96.97 ± 1.6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7947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hiisanosid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 0.3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0.36 ± 0.00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 0.34 ± 0.0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79477"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100.0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96.39 ± 0.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1.01 ± 3.4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79477"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200.0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5.28 ± 0.0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.93 ± 4.9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79477"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500.0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02.70 ± 0.4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01.98 ± 3.0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7947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esami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0.5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 0.49 ± 0.0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 0.51 ± 0.00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79477"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100.0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0 ± 0.2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97.61 ± 1.5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79477"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200.0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.03 ± 0.2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2.08 ± 4.4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79477">
                <a:tc>
                  <a:txBody>
                    <a:bodyPr/>
                    <a:lstStyle/>
                    <a:p>
                      <a:pPr algn="just" fontAlgn="ctr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500.0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93.72 ± 0.5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00.54 ± 2.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</a:tbl>
          </a:graphicData>
        </a:graphic>
      </p:graphicFrame>
      <p:sp>
        <p:nvSpPr>
          <p:cNvPr id="3" name="직사각형 2"/>
          <p:cNvSpPr/>
          <p:nvPr/>
        </p:nvSpPr>
        <p:spPr>
          <a:xfrm>
            <a:off x="2899752" y="194742"/>
            <a:ext cx="6918424" cy="328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fontAlgn="base">
              <a:lnSpc>
                <a:spcPct val="160000"/>
              </a:lnSpc>
            </a:pP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en-US" altLang="ko-KR" sz="1100" kern="0" dirty="0">
                <a:solidFill>
                  <a:srgbClr val="000000"/>
                </a:solidFill>
                <a:latin typeface="Times New Roman" panose="02020603050405020304" pitchFamily="18" charset="0"/>
                <a:ea typeface="함초롬바탕" panose="02030604000101010101" pitchFamily="18" charset="-127"/>
                <a:cs typeface="Times New Roman" panose="02020603050405020304" pitchFamily="18" charset="0"/>
              </a:rPr>
              <a:t>Table 1. Intra-, inter- day assays for determination of the target components in</a:t>
            </a:r>
            <a:r>
              <a:rPr lang="en-US" altLang="ko-KR" sz="1100" i="1" kern="0" dirty="0">
                <a:solidFill>
                  <a:srgbClr val="000000"/>
                </a:solidFill>
                <a:latin typeface="Times New Roman" panose="02020603050405020304" pitchFamily="18" charset="0"/>
                <a:ea typeface="함초롬바탕" panose="02030604000101010101" pitchFamily="18" charset="-127"/>
                <a:cs typeface="Times New Roman" panose="02020603050405020304" pitchFamily="18" charset="0"/>
              </a:rPr>
              <a:t> </a:t>
            </a:r>
            <a:r>
              <a:rPr lang="en-US" altLang="ko-KR" sz="1100" i="1" kern="0" dirty="0" err="1">
                <a:solidFill>
                  <a:srgbClr val="000000"/>
                </a:solidFill>
                <a:latin typeface="Times New Roman" panose="02020603050405020304" pitchFamily="18" charset="0"/>
                <a:ea typeface="함초롬바탕" panose="02030604000101010101" pitchFamily="18" charset="-127"/>
                <a:cs typeface="Times New Roman" panose="02020603050405020304" pitchFamily="18" charset="0"/>
              </a:rPr>
              <a:t>Acanthopanax</a:t>
            </a:r>
            <a:r>
              <a:rPr lang="en-US" altLang="ko-KR" sz="1100" i="1" kern="0" dirty="0">
                <a:solidFill>
                  <a:srgbClr val="000000"/>
                </a:solidFill>
                <a:latin typeface="Times New Roman" panose="02020603050405020304" pitchFamily="18" charset="0"/>
                <a:ea typeface="함초롬바탕" panose="02030604000101010101" pitchFamily="18" charset="-127"/>
                <a:cs typeface="Times New Roman" panose="02020603050405020304" pitchFamily="18" charset="0"/>
              </a:rPr>
              <a:t> 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oot bark </a:t>
            </a:r>
            <a:endParaRPr lang="en-US" altLang="ko-KR" sz="1100" kern="0" spc="0" dirty="0">
              <a:solidFill>
                <a:srgbClr val="0000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2669059" y="5781763"/>
            <a:ext cx="43186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D., standard deviation</a:t>
            </a:r>
          </a:p>
        </p:txBody>
      </p:sp>
    </p:spTree>
    <p:extLst>
      <p:ext uri="{BB962C8B-B14F-4D97-AF65-F5344CB8AC3E}">
        <p14:creationId xmlns:p14="http://schemas.microsoft.com/office/powerpoint/2010/main" val="25521955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4</TotalTime>
  <Words>213</Words>
  <Application>Microsoft Office PowerPoint</Application>
  <PresentationFormat>와이드스크린</PresentationFormat>
  <Paragraphs>67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함초롬바탕</vt:lpstr>
      <vt:lpstr>Arial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yaein3696@naver.com</dc:creator>
  <cp:lastModifiedBy>user</cp:lastModifiedBy>
  <cp:revision>16</cp:revision>
  <cp:lastPrinted>2021-07-21T01:12:46Z</cp:lastPrinted>
  <dcterms:created xsi:type="dcterms:W3CDTF">2018-12-21T03:52:09Z</dcterms:created>
  <dcterms:modified xsi:type="dcterms:W3CDTF">2022-10-12T06:10:35Z</dcterms:modified>
</cp:coreProperties>
</file>